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799763" cy="144033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69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711"/>
              </a:spcBef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9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fld id="{BB5765C9-D9DE-4F09-8357-136FB6DBB260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0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711"/>
              </a:spcBef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endParaRPr b="0" lang="fr-FR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fld id="{C4BA7101-8BCA-4370-87DD-21AF9BD12A1A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D3A31-332B-422F-9AFD-AC3F74609B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9720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41440" y="8324640"/>
            <a:ext cx="9720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D4B4D-108A-413E-AFD3-0B55B12845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522040" y="33602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41440" y="83246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522040" y="83246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36B69-4775-4474-80FF-EF5A5D27C6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312948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827880" y="3360240"/>
            <a:ext cx="312948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113960" y="3360240"/>
            <a:ext cx="312948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41440" y="8324640"/>
            <a:ext cx="312948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827880" y="8324640"/>
            <a:ext cx="312948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113960" y="8324640"/>
            <a:ext cx="312948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B4F95-E8BF-4B46-95AA-863D7CA2F2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41440" y="3360240"/>
            <a:ext cx="9720000" cy="9504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50"/>
              </a:spcBef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AAD38-0BB7-4189-8CD6-6E0774A820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9720000" cy="9504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56C13-863B-4B06-8E5A-B24AF76E91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4743000" cy="9504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522040" y="3360240"/>
            <a:ext cx="4743000" cy="9504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479B6-A449-43D7-A0A7-9E2BCD28CC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05484-8E9C-41A7-807A-801BBA8538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41440" y="577440"/>
            <a:ext cx="9720000" cy="1112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50"/>
              </a:spcBef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08301-A725-4ED3-B3DD-452DB15904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522040" y="3360240"/>
            <a:ext cx="4743000" cy="9504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41440" y="83246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ADD549-C565-43D7-ADAD-4E826C1F83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4743000" cy="9504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522040" y="33602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522040" y="83246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A0AA86-7208-45E4-894B-8781D16E4D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41440" y="33602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522040" y="3360240"/>
            <a:ext cx="4743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41440" y="8324640"/>
            <a:ext cx="9720000" cy="45334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4FAE6-55F4-4E23-A227-384D6FCB6D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41440" y="577440"/>
            <a:ext cx="9720000" cy="239868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 algn="ctr">
              <a:buNone/>
              <a:tabLst>
                <a:tab algn="l" pos="0"/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6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41440" y="3360240"/>
            <a:ext cx="9720000" cy="9504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t">
            <a:normAutofit/>
          </a:bodyPr>
          <a:p>
            <a:pPr marL="534960" indent="-534960"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1" marL="1165320" indent="-446040">
              <a:spcBef>
                <a:spcPts val="1250"/>
              </a:spcBef>
              <a:buClr>
                <a:srgbClr val="000000"/>
              </a:buClr>
              <a:buFont typeface="Arial"/>
              <a:buChar char="–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2" marL="1795320" indent="-355320"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3" marL="2514600" indent="-355680">
              <a:spcBef>
                <a:spcPts val="1250"/>
              </a:spcBef>
              <a:buClr>
                <a:srgbClr val="000000"/>
              </a:buClr>
              <a:buFont typeface="Arial"/>
              <a:buChar char="–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4" marL="3235320" indent="-35568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5" marL="3235320" indent="-35568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6" marL="3235320" indent="-35568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1433520"/>
                <a:tab algn="l" pos="2867040"/>
                <a:tab algn="l" pos="4300560"/>
                <a:tab algn="l" pos="5734080"/>
                <a:tab algn="l" pos="7167600"/>
                <a:tab algn="l" pos="8601120"/>
                <a:tab algn="l" pos="1003464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39280" y="13349160"/>
            <a:ext cx="2519640" cy="765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  <a:defRPr b="0" lang="fr-FR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fr-FR" sz="1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689280" y="13349160"/>
            <a:ext cx="3422880" cy="765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p>
            <a:pPr indent="0"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742160" y="13349160"/>
            <a:ext cx="2519280" cy="765360"/>
          </a:xfrm>
          <a:prstGeom prst="rect">
            <a:avLst/>
          </a:prstGeom>
          <a:noFill/>
          <a:ln w="0">
            <a:noFill/>
          </a:ln>
        </p:spPr>
        <p:txBody>
          <a:bodyPr lIns="144000" rIns="144000" tIns="72000" bIns="720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  <a:defRPr b="0" lang="fr-FR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fld id="{4292344E-472B-4B9D-BB00-4012951B75DA}" type="slidenum">
              <a:rPr b="0" lang="fr-FR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slideLayout" Target="../slideLayouts/slideLayout1.xml"/><Relationship Id="rId1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onnecteur droit 63"/>
          <p:cNvSpPr/>
          <p:nvPr/>
        </p:nvSpPr>
        <p:spPr>
          <a:xfrm>
            <a:off x="8385120" y="10734840"/>
            <a:ext cx="422280" cy="2880"/>
          </a:xfrm>
          <a:prstGeom prst="line">
            <a:avLst/>
          </a:prstGeom>
          <a:ln w="2232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onnecteur droit 64"/>
          <p:cNvSpPr/>
          <p:nvPr/>
        </p:nvSpPr>
        <p:spPr>
          <a:xfrm>
            <a:off x="8385120" y="11128320"/>
            <a:ext cx="422280" cy="4680"/>
          </a:xfrm>
          <a:prstGeom prst="line">
            <a:avLst/>
          </a:prstGeom>
          <a:ln w="2232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65"/>
          <p:cNvSpPr/>
          <p:nvPr/>
        </p:nvSpPr>
        <p:spPr>
          <a:xfrm>
            <a:off x="8807400" y="10883880"/>
            <a:ext cx="199404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al-time PC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ZoneTexte 66"/>
          <p:cNvSpPr/>
          <p:nvPr/>
        </p:nvSpPr>
        <p:spPr>
          <a:xfrm>
            <a:off x="8807400" y="10483920"/>
            <a:ext cx="1349280" cy="38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croarra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ZoneTexte 84"/>
          <p:cNvSpPr/>
          <p:nvPr/>
        </p:nvSpPr>
        <p:spPr>
          <a:xfrm>
            <a:off x="1112760" y="685800"/>
            <a:ext cx="143028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179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RING (R=0.90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28"/>
          <p:cNvSpPr/>
          <p:nvPr/>
        </p:nvSpPr>
        <p:spPr>
          <a:xfrm rot="16200000">
            <a:off x="-540720" y="2069280"/>
            <a:ext cx="16909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ZoneTexte 29"/>
          <p:cNvSpPr/>
          <p:nvPr/>
        </p:nvSpPr>
        <p:spPr>
          <a:xfrm rot="5400000">
            <a:off x="2451960" y="2069640"/>
            <a:ext cx="16873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ZoneTexte 54"/>
          <p:cNvSpPr/>
          <p:nvPr/>
        </p:nvSpPr>
        <p:spPr>
          <a:xfrm>
            <a:off x="542880" y="63648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Graphique 61" descr=""/>
          <p:cNvPicPr/>
          <p:nvPr/>
        </p:nvPicPr>
        <p:blipFill>
          <a:blip r:embed="rId1"/>
          <a:stretch/>
        </p:blipFill>
        <p:spPr>
          <a:xfrm>
            <a:off x="360360" y="706320"/>
            <a:ext cx="2882880" cy="2543400"/>
          </a:xfrm>
          <a:prstGeom prst="rect">
            <a:avLst/>
          </a:prstGeom>
          <a:ln w="0">
            <a:noFill/>
          </a:ln>
        </p:spPr>
      </p:pic>
      <p:sp>
        <p:nvSpPr>
          <p:cNvPr id="57" name="ZoneTexte 93"/>
          <p:cNvSpPr/>
          <p:nvPr/>
        </p:nvSpPr>
        <p:spPr>
          <a:xfrm>
            <a:off x="4714920" y="685800"/>
            <a:ext cx="147960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51320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Cul3-BTB (R=0.39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ZoneTexte 55"/>
          <p:cNvSpPr/>
          <p:nvPr/>
        </p:nvSpPr>
        <p:spPr>
          <a:xfrm>
            <a:off x="4257720" y="63648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ZoneTexte 82"/>
          <p:cNvSpPr/>
          <p:nvPr/>
        </p:nvSpPr>
        <p:spPr>
          <a:xfrm rot="16200000">
            <a:off x="3059640" y="2069280"/>
            <a:ext cx="16909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83"/>
          <p:cNvSpPr/>
          <p:nvPr/>
        </p:nvSpPr>
        <p:spPr>
          <a:xfrm rot="5400000">
            <a:off x="6052320" y="2069640"/>
            <a:ext cx="16873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Graphique 62" descr=""/>
          <p:cNvPicPr/>
          <p:nvPr/>
        </p:nvPicPr>
        <p:blipFill>
          <a:blip r:embed="rId2"/>
          <a:stretch/>
        </p:blipFill>
        <p:spPr>
          <a:xfrm>
            <a:off x="3889440" y="1079640"/>
            <a:ext cx="3170160" cy="2492280"/>
          </a:xfrm>
          <a:prstGeom prst="rect">
            <a:avLst/>
          </a:prstGeom>
          <a:ln w="0">
            <a:noFill/>
          </a:ln>
        </p:spPr>
      </p:pic>
      <p:sp>
        <p:nvSpPr>
          <p:cNvPr id="62" name="ZoneTexte 97"/>
          <p:cNvSpPr/>
          <p:nvPr/>
        </p:nvSpPr>
        <p:spPr>
          <a:xfrm>
            <a:off x="8400960" y="685800"/>
            <a:ext cx="123048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4304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SCF (R=0.97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52"/>
          <p:cNvSpPr/>
          <p:nvPr/>
        </p:nvSpPr>
        <p:spPr>
          <a:xfrm>
            <a:off x="7829640" y="63648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ZoneTexte 80"/>
          <p:cNvSpPr/>
          <p:nvPr/>
        </p:nvSpPr>
        <p:spPr>
          <a:xfrm rot="16200000">
            <a:off x="6696360" y="2069280"/>
            <a:ext cx="16909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ZoneTexte 81"/>
          <p:cNvSpPr/>
          <p:nvPr/>
        </p:nvSpPr>
        <p:spPr>
          <a:xfrm rot="5400000">
            <a:off x="9652680" y="2069640"/>
            <a:ext cx="168732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Graphique 65" descr=""/>
          <p:cNvPicPr/>
          <p:nvPr/>
        </p:nvPicPr>
        <p:blipFill>
          <a:blip r:embed="rId3"/>
          <a:stretch/>
        </p:blipFill>
        <p:spPr>
          <a:xfrm>
            <a:off x="7486560" y="1079640"/>
            <a:ext cx="3029040" cy="2266920"/>
          </a:xfrm>
          <a:prstGeom prst="rect">
            <a:avLst/>
          </a:prstGeom>
          <a:ln w="0">
            <a:noFill/>
          </a:ln>
        </p:spPr>
      </p:pic>
      <p:sp>
        <p:nvSpPr>
          <p:cNvPr id="67" name="ZoneTexte 95"/>
          <p:cNvSpPr/>
          <p:nvPr/>
        </p:nvSpPr>
        <p:spPr>
          <a:xfrm>
            <a:off x="1198440" y="3763800"/>
            <a:ext cx="125748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8703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SCF (R=0.79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56"/>
          <p:cNvSpPr/>
          <p:nvPr/>
        </p:nvSpPr>
        <p:spPr>
          <a:xfrm>
            <a:off x="542880" y="372420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78"/>
          <p:cNvSpPr/>
          <p:nvPr/>
        </p:nvSpPr>
        <p:spPr>
          <a:xfrm rot="16200000">
            <a:off x="-541440" y="5146560"/>
            <a:ext cx="169236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79"/>
          <p:cNvSpPr/>
          <p:nvPr/>
        </p:nvSpPr>
        <p:spPr>
          <a:xfrm rot="5400000">
            <a:off x="2452680" y="5146920"/>
            <a:ext cx="168588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Graphique 66" descr=""/>
          <p:cNvPicPr/>
          <p:nvPr/>
        </p:nvPicPr>
        <p:blipFill>
          <a:blip r:embed="rId4"/>
          <a:stretch/>
        </p:blipFill>
        <p:spPr>
          <a:xfrm>
            <a:off x="360360" y="4243320"/>
            <a:ext cx="3095640" cy="2163960"/>
          </a:xfrm>
          <a:prstGeom prst="rect">
            <a:avLst/>
          </a:prstGeom>
          <a:ln w="0">
            <a:noFill/>
          </a:ln>
        </p:spPr>
      </p:pic>
      <p:sp>
        <p:nvSpPr>
          <p:cNvPr id="72" name="ZoneTexte 88"/>
          <p:cNvSpPr/>
          <p:nvPr/>
        </p:nvSpPr>
        <p:spPr>
          <a:xfrm>
            <a:off x="4859280" y="6834240"/>
            <a:ext cx="119052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18914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SCF (R=0.58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ZoneTexte 60"/>
          <p:cNvSpPr/>
          <p:nvPr/>
        </p:nvSpPr>
        <p:spPr>
          <a:xfrm>
            <a:off x="4257720" y="6792840"/>
            <a:ext cx="21276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ZoneTexte 86"/>
          <p:cNvSpPr/>
          <p:nvPr/>
        </p:nvSpPr>
        <p:spPr>
          <a:xfrm rot="16200000">
            <a:off x="6694920" y="8306640"/>
            <a:ext cx="169380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ZoneTexte 109"/>
          <p:cNvSpPr/>
          <p:nvPr/>
        </p:nvSpPr>
        <p:spPr>
          <a:xfrm rot="16200000">
            <a:off x="3057840" y="8162280"/>
            <a:ext cx="169416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ZoneTexte 111"/>
          <p:cNvSpPr/>
          <p:nvPr/>
        </p:nvSpPr>
        <p:spPr>
          <a:xfrm rot="5400000">
            <a:off x="6053760" y="8162280"/>
            <a:ext cx="168408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Graphique 78" descr=""/>
          <p:cNvPicPr/>
          <p:nvPr/>
        </p:nvPicPr>
        <p:blipFill>
          <a:blip r:embed="rId5"/>
          <a:stretch/>
        </p:blipFill>
        <p:spPr>
          <a:xfrm>
            <a:off x="4035600" y="7370640"/>
            <a:ext cx="3382920" cy="2340000"/>
          </a:xfrm>
          <a:prstGeom prst="rect">
            <a:avLst/>
          </a:prstGeom>
          <a:ln w="0">
            <a:noFill/>
          </a:ln>
        </p:spPr>
      </p:pic>
      <p:sp>
        <p:nvSpPr>
          <p:cNvPr id="78" name="ZoneTexte 104"/>
          <p:cNvSpPr/>
          <p:nvPr/>
        </p:nvSpPr>
        <p:spPr>
          <a:xfrm>
            <a:off x="1181160" y="6834240"/>
            <a:ext cx="129204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47216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SCF (R=0.87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ZoneTexte 57"/>
          <p:cNvSpPr/>
          <p:nvPr/>
        </p:nvSpPr>
        <p:spPr>
          <a:xfrm>
            <a:off x="542880" y="679284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ZoneTexte 112"/>
          <p:cNvSpPr/>
          <p:nvPr/>
        </p:nvSpPr>
        <p:spPr>
          <a:xfrm rot="16200000">
            <a:off x="-542520" y="8162280"/>
            <a:ext cx="169416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ZoneTexte 113"/>
          <p:cNvSpPr/>
          <p:nvPr/>
        </p:nvSpPr>
        <p:spPr>
          <a:xfrm rot="5400000">
            <a:off x="2453400" y="8162280"/>
            <a:ext cx="168408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Graphique 79" descr=""/>
          <p:cNvPicPr/>
          <p:nvPr/>
        </p:nvPicPr>
        <p:blipFill>
          <a:blip r:embed="rId6"/>
          <a:stretch/>
        </p:blipFill>
        <p:spPr>
          <a:xfrm>
            <a:off x="433440" y="7370640"/>
            <a:ext cx="2663640" cy="2419560"/>
          </a:xfrm>
          <a:prstGeom prst="rect">
            <a:avLst/>
          </a:prstGeom>
          <a:ln w="0">
            <a:noFill/>
          </a:ln>
        </p:spPr>
      </p:pic>
      <p:sp>
        <p:nvSpPr>
          <p:cNvPr id="83" name="ZoneTexte 90"/>
          <p:cNvSpPr/>
          <p:nvPr/>
        </p:nvSpPr>
        <p:spPr>
          <a:xfrm>
            <a:off x="8405640" y="3786120"/>
            <a:ext cx="122256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5808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SCF (R=0.81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ZoneTexte 58"/>
          <p:cNvSpPr/>
          <p:nvPr/>
        </p:nvSpPr>
        <p:spPr>
          <a:xfrm>
            <a:off x="7829640" y="374508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ZoneTexte 114"/>
          <p:cNvSpPr/>
          <p:nvPr/>
        </p:nvSpPr>
        <p:spPr>
          <a:xfrm rot="16200000">
            <a:off x="6694920" y="5114160"/>
            <a:ext cx="169380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ZoneTexte 115"/>
          <p:cNvSpPr/>
          <p:nvPr/>
        </p:nvSpPr>
        <p:spPr>
          <a:xfrm rot="5400000">
            <a:off x="9654120" y="5114520"/>
            <a:ext cx="168444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Graphique 80" descr=""/>
          <p:cNvPicPr/>
          <p:nvPr/>
        </p:nvPicPr>
        <p:blipFill>
          <a:blip r:embed="rId7"/>
          <a:stretch/>
        </p:blipFill>
        <p:spPr>
          <a:xfrm>
            <a:off x="7632720" y="4237200"/>
            <a:ext cx="2717640" cy="2523960"/>
          </a:xfrm>
          <a:prstGeom prst="rect">
            <a:avLst/>
          </a:prstGeom>
          <a:ln w="0">
            <a:noFill/>
          </a:ln>
        </p:spPr>
      </p:pic>
      <p:sp>
        <p:nvSpPr>
          <p:cNvPr id="88" name="ZoneTexte 22"/>
          <p:cNvSpPr/>
          <p:nvPr/>
        </p:nvSpPr>
        <p:spPr>
          <a:xfrm>
            <a:off x="4857840" y="3786120"/>
            <a:ext cx="119376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3363 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3 U-box (R=0.82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ZoneTexte 53"/>
          <p:cNvSpPr/>
          <p:nvPr/>
        </p:nvSpPr>
        <p:spPr>
          <a:xfrm>
            <a:off x="4257720" y="374508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ZoneTexte 106"/>
          <p:cNvSpPr/>
          <p:nvPr/>
        </p:nvSpPr>
        <p:spPr>
          <a:xfrm rot="16200000">
            <a:off x="3058200" y="5114160"/>
            <a:ext cx="169380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ZoneTexte 107"/>
          <p:cNvSpPr/>
          <p:nvPr/>
        </p:nvSpPr>
        <p:spPr>
          <a:xfrm rot="5400000">
            <a:off x="6053760" y="5114520"/>
            <a:ext cx="168444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Graphique 81" descr=""/>
          <p:cNvPicPr/>
          <p:nvPr/>
        </p:nvPicPr>
        <p:blipFill>
          <a:blip r:embed="rId8"/>
          <a:stretch/>
        </p:blipFill>
        <p:spPr>
          <a:xfrm>
            <a:off x="3962520" y="4248000"/>
            <a:ext cx="2950920" cy="2579760"/>
          </a:xfrm>
          <a:prstGeom prst="rect">
            <a:avLst/>
          </a:prstGeom>
          <a:ln w="0">
            <a:noFill/>
          </a:ln>
        </p:spPr>
      </p:pic>
      <p:sp>
        <p:nvSpPr>
          <p:cNvPr id="93" name="ZoneTexte 116"/>
          <p:cNvSpPr/>
          <p:nvPr/>
        </p:nvSpPr>
        <p:spPr>
          <a:xfrm>
            <a:off x="8420040" y="6834240"/>
            <a:ext cx="119376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5411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UX (R=0.90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ZoneTexte 61"/>
          <p:cNvSpPr/>
          <p:nvPr/>
        </p:nvSpPr>
        <p:spPr>
          <a:xfrm>
            <a:off x="7829640" y="6730920"/>
            <a:ext cx="21276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ZoneTexte 91"/>
          <p:cNvSpPr/>
          <p:nvPr/>
        </p:nvSpPr>
        <p:spPr>
          <a:xfrm rot="5400000">
            <a:off x="9654120" y="8307000"/>
            <a:ext cx="168444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Graphique 82" descr=""/>
          <p:cNvPicPr/>
          <p:nvPr/>
        </p:nvPicPr>
        <p:blipFill>
          <a:blip r:embed="rId9"/>
          <a:stretch/>
        </p:blipFill>
        <p:spPr>
          <a:xfrm>
            <a:off x="7486560" y="7259760"/>
            <a:ext cx="2955960" cy="2481120"/>
          </a:xfrm>
          <a:prstGeom prst="rect">
            <a:avLst/>
          </a:prstGeom>
          <a:ln w="0">
            <a:noFill/>
          </a:ln>
        </p:spPr>
      </p:pic>
      <p:sp>
        <p:nvSpPr>
          <p:cNvPr id="97" name="ZoneTexte 110"/>
          <p:cNvSpPr/>
          <p:nvPr/>
        </p:nvSpPr>
        <p:spPr>
          <a:xfrm>
            <a:off x="1216080" y="10050480"/>
            <a:ext cx="1222200" cy="54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427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 (R=0.93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ZoneTexte 62"/>
          <p:cNvSpPr/>
          <p:nvPr/>
        </p:nvSpPr>
        <p:spPr>
          <a:xfrm>
            <a:off x="542880" y="992664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ZoneTexte 102"/>
          <p:cNvSpPr/>
          <p:nvPr/>
        </p:nvSpPr>
        <p:spPr>
          <a:xfrm rot="16200000">
            <a:off x="-541440" y="11501280"/>
            <a:ext cx="169236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ZoneTexte 105"/>
          <p:cNvSpPr/>
          <p:nvPr/>
        </p:nvSpPr>
        <p:spPr>
          <a:xfrm rot="5400000">
            <a:off x="2452680" y="11501640"/>
            <a:ext cx="168588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1" name="Graphique 83" descr=""/>
          <p:cNvPicPr/>
          <p:nvPr/>
        </p:nvPicPr>
        <p:blipFill>
          <a:blip r:embed="rId10"/>
          <a:stretch/>
        </p:blipFill>
        <p:spPr>
          <a:xfrm>
            <a:off x="426960" y="10564920"/>
            <a:ext cx="2743200" cy="2352600"/>
          </a:xfrm>
          <a:prstGeom prst="rect">
            <a:avLst/>
          </a:prstGeom>
          <a:ln w="0">
            <a:noFill/>
          </a:ln>
        </p:spPr>
      </p:pic>
      <p:sp>
        <p:nvSpPr>
          <p:cNvPr id="102" name="ZoneTexte 108"/>
          <p:cNvSpPr/>
          <p:nvPr/>
        </p:nvSpPr>
        <p:spPr>
          <a:xfrm>
            <a:off x="4913280" y="10050480"/>
            <a:ext cx="1082880" cy="73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44000" rIns="144000" tIns="72000" bIns="720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.985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K (R=0.93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ZoneTexte 59"/>
          <p:cNvSpPr/>
          <p:nvPr/>
        </p:nvSpPr>
        <p:spPr>
          <a:xfrm>
            <a:off x="4257720" y="9926640"/>
            <a:ext cx="21420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ZoneTexte 100"/>
          <p:cNvSpPr/>
          <p:nvPr/>
        </p:nvSpPr>
        <p:spPr>
          <a:xfrm rot="16200000">
            <a:off x="3058920" y="11501280"/>
            <a:ext cx="169236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ray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ZoneTexte 101"/>
          <p:cNvSpPr/>
          <p:nvPr/>
        </p:nvSpPr>
        <p:spPr>
          <a:xfrm rot="5400000">
            <a:off x="6053040" y="11501640"/>
            <a:ext cx="1685880" cy="3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1680" rIns="121680" tIns="60840" bIns="6084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1440000"/>
                <a:tab algn="l" pos="2879640"/>
                <a:tab algn="l" pos="4319640"/>
                <a:tab algn="l" pos="5759280"/>
                <a:tab algn="l" pos="7199280"/>
                <a:tab algn="l" pos="8639280"/>
                <a:tab algn="l" pos="1007892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PCR signal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Graphique 84" descr=""/>
          <p:cNvPicPr/>
          <p:nvPr/>
        </p:nvPicPr>
        <p:blipFill>
          <a:blip r:embed="rId11"/>
          <a:stretch/>
        </p:blipFill>
        <p:spPr>
          <a:xfrm>
            <a:off x="3889440" y="10564920"/>
            <a:ext cx="2468520" cy="246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6T13:17:45Z</dcterms:created>
  <dc:creator>Delphine</dc:creator>
  <dc:description/>
  <dc:language>en-US</dc:language>
  <cp:lastModifiedBy>Delphine</cp:lastModifiedBy>
  <dcterms:modified xsi:type="dcterms:W3CDTF">2011-11-18T15:35:29Z</dcterms:modified>
  <cp:revision>14</cp:revision>
  <dc:subject/>
  <dc:title>Diapositive 1</dc:title>
</cp:coreProperties>
</file>